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51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765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252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2757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024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595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985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383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905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75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0854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500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6341B-BA4A-40C9-9015-7C528A2392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210A9-1D99-449D-AB9F-1E5B06070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078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2644" y="3963534"/>
            <a:ext cx="3815355" cy="289446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2585" y="1231718"/>
            <a:ext cx="3928489" cy="303928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3035" y="1245103"/>
            <a:ext cx="3884766" cy="30054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5819" y="4131584"/>
            <a:ext cx="3741922" cy="268257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521557" y="3962564"/>
            <a:ext cx="32704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igarette smokers vs. Dual smokers</a:t>
            </a:r>
            <a:endParaRPr lang="en-US" sz="14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7152780" y="3999399"/>
            <a:ext cx="34032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pipe</a:t>
            </a:r>
            <a:r>
              <a:rPr lang="en-US" sz="1400" b="1" u="sng" smtClean="0">
                <a:latin typeface="Arial" panose="020B0604020202020204" pitchFamily="34" charset="0"/>
                <a:cs typeface="Arial" panose="020B0604020202020204" pitchFamily="34" charset="0"/>
              </a:rPr>
              <a:t> smokers vs</a:t>
            </a:r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Dual </a:t>
            </a:r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smokers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893573" y="222833"/>
            <a:ext cx="86624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en-US" b="1" u="sng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u="sng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Volcano plot of differentially expressed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microRNA in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garette smokers, </a:t>
            </a:r>
            <a:r>
              <a:rPr lang="en-US" b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aterpipe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mokers,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ual smokers and </a:t>
            </a:r>
            <a:r>
              <a:rPr lang="en-US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-cigarette users</a:t>
            </a:r>
            <a:endParaRPr lang="en-US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b="1" dirty="0"/>
          </a:p>
        </p:txBody>
      </p:sp>
      <p:sp>
        <p:nvSpPr>
          <p:cNvPr id="7" name="Rectangle 6"/>
          <p:cNvSpPr/>
          <p:nvPr/>
        </p:nvSpPr>
        <p:spPr>
          <a:xfrm>
            <a:off x="2550345" y="1180756"/>
            <a:ext cx="311014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E-cig users vs. Cigarette </a:t>
            </a:r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smokers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219770" y="1134773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.</a:t>
            </a:r>
            <a:endParaRPr 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6841180" y="1180756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.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6845989" y="3982742"/>
            <a:ext cx="38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  <a:r>
              <a:rPr lang="en-US" b="1" dirty="0" smtClean="0"/>
              <a:t>.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7152780" y="1195546"/>
            <a:ext cx="37673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pipe</a:t>
            </a:r>
            <a:r>
              <a:rPr lang="en-US" sz="14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 smokers vs</a:t>
            </a:r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Cigarette </a:t>
            </a:r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smokers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203107" y="3942235"/>
            <a:ext cx="4834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Arial" panose="020B0604020202020204" pitchFamily="34" charset="0"/>
              </a:rPr>
              <a:t>C.</a:t>
            </a:r>
            <a:endParaRPr lang="en-US" b="1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08640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55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Kameshwar</dc:creator>
  <cp:lastModifiedBy>Rahman, Irfan</cp:lastModifiedBy>
  <cp:revision>16</cp:revision>
  <dcterms:created xsi:type="dcterms:W3CDTF">2019-10-09T20:29:40Z</dcterms:created>
  <dcterms:modified xsi:type="dcterms:W3CDTF">2020-06-12T05:15:34Z</dcterms:modified>
</cp:coreProperties>
</file>